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6858000" cy="9906000" type="A4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CC"/>
    <a:srgbClr val="FF0066"/>
    <a:srgbClr val="FF9933"/>
    <a:srgbClr val="0066CC"/>
    <a:srgbClr val="009900"/>
    <a:srgbClr val="0066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4" d="100"/>
          <a:sy n="74" d="100"/>
        </p:scale>
        <p:origin x="253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KronosWT vs Kr3161Zip4 WT graph'!$A$2</c:f>
              <c:strCache>
                <c:ptCount val="1"/>
                <c:pt idx="0">
                  <c:v>WT Kronos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KronosWT vs Kr3161Zip4 WT graph'!$B$5:$F$5</c:f>
                <c:numCache>
                  <c:formatCode>General</c:formatCode>
                  <c:ptCount val="5"/>
                  <c:pt idx="0">
                    <c:v>0.05</c:v>
                  </c:pt>
                  <c:pt idx="1">
                    <c:v>0.1</c:v>
                  </c:pt>
                  <c:pt idx="2">
                    <c:v>0.1</c:v>
                  </c:pt>
                  <c:pt idx="3">
                    <c:v>0.11</c:v>
                  </c:pt>
                  <c:pt idx="4">
                    <c:v>0.13</c:v>
                  </c:pt>
                </c:numCache>
              </c:numRef>
            </c:plus>
            <c:minus>
              <c:numRef>
                <c:f>'KronosWT vs Kr3161Zip4 WT graph'!$B$5:$F$5</c:f>
                <c:numCache>
                  <c:formatCode>General</c:formatCode>
                  <c:ptCount val="5"/>
                  <c:pt idx="0">
                    <c:v>0.05</c:v>
                  </c:pt>
                  <c:pt idx="1">
                    <c:v>0.1</c:v>
                  </c:pt>
                  <c:pt idx="2">
                    <c:v>0.1</c:v>
                  </c:pt>
                  <c:pt idx="3">
                    <c:v>0.11</c:v>
                  </c:pt>
                  <c:pt idx="4">
                    <c:v>0.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KronosWT vs Kr3161Zip4 WT graph'!$B$1:$F$1</c:f>
              <c:strCache>
                <c:ptCount val="5"/>
                <c:pt idx="0">
                  <c:v>Univalents</c:v>
                </c:pt>
                <c:pt idx="1">
                  <c:v>Rods</c:v>
                </c:pt>
                <c:pt idx="2">
                  <c:v>Rings</c:v>
                </c:pt>
                <c:pt idx="3">
                  <c:v>Single chiasmata</c:v>
                </c:pt>
                <c:pt idx="4">
                  <c:v>Double chiasmata</c:v>
                </c:pt>
              </c:strCache>
            </c:strRef>
          </c:cat>
          <c:val>
            <c:numRef>
              <c:f>'KronosWT vs Kr3161Zip4 WT graph'!$B$2:$F$2</c:f>
              <c:numCache>
                <c:formatCode>0.00</c:formatCode>
                <c:ptCount val="5"/>
                <c:pt idx="0">
                  <c:v>0.19</c:v>
                </c:pt>
                <c:pt idx="1">
                  <c:v>1.56</c:v>
                </c:pt>
                <c:pt idx="2">
                  <c:v>12.35</c:v>
                </c:pt>
                <c:pt idx="3">
                  <c:v>26.25</c:v>
                </c:pt>
                <c:pt idx="4">
                  <c:v>28.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34-4589-9934-8D460B1E0750}"/>
            </c:ext>
          </c:extLst>
        </c:ser>
        <c:ser>
          <c:idx val="1"/>
          <c:order val="1"/>
          <c:tx>
            <c:strRef>
              <c:f>'KronosWT vs Kr3161Zip4 WT graph'!$A$3</c:f>
              <c:strCache>
                <c:ptCount val="1"/>
                <c:pt idx="0">
                  <c:v>Kr3161 WT</c:v>
                </c:pt>
              </c:strCache>
            </c:strRef>
          </c:tx>
          <c:spPr>
            <a:solidFill>
              <a:srgbClr val="FF99CC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KronosWT vs Kr3161Zip4 WT graph'!$B$6:$F$6</c:f>
                <c:numCache>
                  <c:formatCode>General</c:formatCode>
                  <c:ptCount val="5"/>
                  <c:pt idx="0">
                    <c:v>0.06</c:v>
                  </c:pt>
                  <c:pt idx="1">
                    <c:v>0.1</c:v>
                  </c:pt>
                  <c:pt idx="2">
                    <c:v>0.1</c:v>
                  </c:pt>
                  <c:pt idx="3">
                    <c:v>0.12</c:v>
                  </c:pt>
                  <c:pt idx="4">
                    <c:v>0.12</c:v>
                  </c:pt>
                </c:numCache>
              </c:numRef>
            </c:plus>
            <c:minus>
              <c:numRef>
                <c:f>'KronosWT vs Kr3161Zip4 WT graph'!$B$6:$F$6</c:f>
                <c:numCache>
                  <c:formatCode>General</c:formatCode>
                  <c:ptCount val="5"/>
                  <c:pt idx="0">
                    <c:v>0.06</c:v>
                  </c:pt>
                  <c:pt idx="1">
                    <c:v>0.1</c:v>
                  </c:pt>
                  <c:pt idx="2">
                    <c:v>0.1</c:v>
                  </c:pt>
                  <c:pt idx="3">
                    <c:v>0.12</c:v>
                  </c:pt>
                  <c:pt idx="4">
                    <c:v>0.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KronosWT vs Kr3161Zip4 WT graph'!$B$1:$F$1</c:f>
              <c:strCache>
                <c:ptCount val="5"/>
                <c:pt idx="0">
                  <c:v>Univalents</c:v>
                </c:pt>
                <c:pt idx="1">
                  <c:v>Rods</c:v>
                </c:pt>
                <c:pt idx="2">
                  <c:v>Rings</c:v>
                </c:pt>
                <c:pt idx="3">
                  <c:v>Single chiasmata</c:v>
                </c:pt>
                <c:pt idx="4">
                  <c:v>Double chiasmata</c:v>
                </c:pt>
              </c:strCache>
            </c:strRef>
          </c:cat>
          <c:val>
            <c:numRef>
              <c:f>'KronosWT vs Kr3161Zip4 WT graph'!$B$3:$F$3</c:f>
              <c:numCache>
                <c:formatCode>0.00</c:formatCode>
                <c:ptCount val="5"/>
                <c:pt idx="0">
                  <c:v>0.31</c:v>
                </c:pt>
                <c:pt idx="1">
                  <c:v>1.74</c:v>
                </c:pt>
                <c:pt idx="2">
                  <c:v>12.1</c:v>
                </c:pt>
                <c:pt idx="3">
                  <c:v>25.94</c:v>
                </c:pt>
                <c:pt idx="4">
                  <c:v>28.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134-4589-9934-8D460B1E07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72864640"/>
        <c:axId val="972852992"/>
      </c:barChart>
      <c:catAx>
        <c:axId val="9728646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72852992"/>
        <c:crosses val="autoZero"/>
        <c:auto val="1"/>
        <c:lblAlgn val="ctr"/>
        <c:lblOffset val="100"/>
        <c:noMultiLvlLbl val="0"/>
      </c:catAx>
      <c:valAx>
        <c:axId val="972852992"/>
        <c:scaling>
          <c:orientation val="minMax"/>
          <c:max val="3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b="1" dirty="0"/>
                  <a:t>Number of</a:t>
                </a:r>
              </a:p>
              <a:p>
                <a:pPr>
                  <a:defRPr b="1"/>
                </a:pPr>
                <a:r>
                  <a:rPr lang="en-GB" b="1" dirty="0"/>
                  <a:t>chromosomes/chiasmata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out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72864640"/>
        <c:crosses val="autoZero"/>
        <c:crossBetween val="between"/>
        <c:majorUnit val="10"/>
        <c:minorUnit val="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EBABD-D59A-4AF1-8B8D-54A220173DFA}" type="datetimeFigureOut">
              <a:rPr lang="es-ES" smtClean="0"/>
              <a:t>16/03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A2AC3-3DF5-4C3E-BE02-37BBE5DB40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2969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EBABD-D59A-4AF1-8B8D-54A220173DFA}" type="datetimeFigureOut">
              <a:rPr lang="es-ES" smtClean="0"/>
              <a:t>16/03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A2AC3-3DF5-4C3E-BE02-37BBE5DB40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65831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EBABD-D59A-4AF1-8B8D-54A220173DFA}" type="datetimeFigureOut">
              <a:rPr lang="es-ES" smtClean="0"/>
              <a:t>16/03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A2AC3-3DF5-4C3E-BE02-37BBE5DB40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59983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EBABD-D59A-4AF1-8B8D-54A220173DFA}" type="datetimeFigureOut">
              <a:rPr lang="es-ES" smtClean="0"/>
              <a:t>16/03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A2AC3-3DF5-4C3E-BE02-37BBE5DB40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490501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EBABD-D59A-4AF1-8B8D-54A220173DFA}" type="datetimeFigureOut">
              <a:rPr lang="es-ES" smtClean="0"/>
              <a:t>16/03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A2AC3-3DF5-4C3E-BE02-37BBE5DB40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71481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EBABD-D59A-4AF1-8B8D-54A220173DFA}" type="datetimeFigureOut">
              <a:rPr lang="es-ES" smtClean="0"/>
              <a:t>16/03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A2AC3-3DF5-4C3E-BE02-37BBE5DB40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74750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EBABD-D59A-4AF1-8B8D-54A220173DFA}" type="datetimeFigureOut">
              <a:rPr lang="es-ES" smtClean="0"/>
              <a:t>16/03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A2AC3-3DF5-4C3E-BE02-37BBE5DB40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772916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EBABD-D59A-4AF1-8B8D-54A220173DFA}" type="datetimeFigureOut">
              <a:rPr lang="es-ES" smtClean="0"/>
              <a:t>16/03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A2AC3-3DF5-4C3E-BE02-37BBE5DB40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21163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EBABD-D59A-4AF1-8B8D-54A220173DFA}" type="datetimeFigureOut">
              <a:rPr lang="es-ES" smtClean="0"/>
              <a:t>16/03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A2AC3-3DF5-4C3E-BE02-37BBE5DB40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69730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EBABD-D59A-4AF1-8B8D-54A220173DFA}" type="datetimeFigureOut">
              <a:rPr lang="es-ES" smtClean="0"/>
              <a:t>16/03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A2AC3-3DF5-4C3E-BE02-37BBE5DB40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3286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EBABD-D59A-4AF1-8B8D-54A220173DFA}" type="datetimeFigureOut">
              <a:rPr lang="es-ES" smtClean="0"/>
              <a:t>16/03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A2AC3-3DF5-4C3E-BE02-37BBE5DB40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12429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AEBABD-D59A-4AF1-8B8D-54A220173DFA}" type="datetimeFigureOut">
              <a:rPr lang="es-ES" smtClean="0"/>
              <a:t>16/03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EA2AC3-3DF5-4C3E-BE02-37BBE5DB401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5514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Gráfico 1">
            <a:extLst>
              <a:ext uri="{FF2B5EF4-FFF2-40B4-BE49-F238E27FC236}">
                <a16:creationId xmlns:a16="http://schemas.microsoft.com/office/drawing/2014/main" id="{702932A5-E869-5974-14D2-56B8C2A5E5B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2305561"/>
              </p:ext>
            </p:extLst>
          </p:nvPr>
        </p:nvGraphicFramePr>
        <p:xfrm>
          <a:off x="696549" y="903824"/>
          <a:ext cx="4942401" cy="27747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0FC9BD12-06D6-D839-F8BB-21A04801F0EF}"/>
              </a:ext>
            </a:extLst>
          </p:cNvPr>
          <p:cNvSpPr txBox="1"/>
          <p:nvPr/>
        </p:nvSpPr>
        <p:spPr>
          <a:xfrm>
            <a:off x="438411" y="175364"/>
            <a:ext cx="17817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82C5599-227C-48A8-E5C6-4D5B8C37B850}"/>
              </a:ext>
            </a:extLst>
          </p:cNvPr>
          <p:cNvSpPr txBox="1"/>
          <p:nvPr/>
        </p:nvSpPr>
        <p:spPr>
          <a:xfrm>
            <a:off x="696549" y="3959667"/>
            <a:ext cx="5536825" cy="11696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</a:t>
            </a:r>
            <a:endParaRPr lang="en-GB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lumn chart showing genotypic effects on meiotic metaphase I chromosomes of Kronos wild type and Kr3161 </a:t>
            </a:r>
            <a:r>
              <a:rPr lang="en-GB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tZIP4-A1B1B2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ntrol plants. The numbers of univalents, rod and ring bivalents and single and double chiasmata are shown.  Multivalents are not shown. Error bars show standard error. </a:t>
            </a:r>
            <a:endParaRPr lang="en-GB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84193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2</TotalTime>
  <Words>59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ía Dolores Rey Santome</dc:creator>
  <cp:lastModifiedBy>Tracie Draeger (JIC)</cp:lastModifiedBy>
  <cp:revision>36</cp:revision>
  <cp:lastPrinted>2023-01-25T15:14:25Z</cp:lastPrinted>
  <dcterms:created xsi:type="dcterms:W3CDTF">2022-12-20T07:57:32Z</dcterms:created>
  <dcterms:modified xsi:type="dcterms:W3CDTF">2023-03-16T17:00:57Z</dcterms:modified>
</cp:coreProperties>
</file>